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sldIdLst>
    <p:sldId id="256" r:id="rId2"/>
  </p:sldIdLst>
  <p:sldSz cx="7199313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846" autoAdjust="0"/>
  </p:normalViewPr>
  <p:slideViewPr>
    <p:cSldViewPr snapToGrid="0">
      <p:cViewPr varScale="1">
        <p:scale>
          <a:sx n="44" d="100"/>
          <a:sy n="44" d="100"/>
        </p:scale>
        <p:origin x="2116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19070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38139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57209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76278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95348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514417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933487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352556" algn="l" defTabSz="838139" rtl="0" eaLnBrk="1" latinLnBrk="0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414125"/>
            <a:ext cx="6119416" cy="3008266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4538401"/>
            <a:ext cx="5399485" cy="2086184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0677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92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460041"/>
            <a:ext cx="1552352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460041"/>
            <a:ext cx="4567064" cy="732264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8745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39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154193"/>
            <a:ext cx="6209407" cy="3594317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5782513"/>
            <a:ext cx="6209407" cy="1890166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311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300203"/>
            <a:ext cx="3059708" cy="54824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300203"/>
            <a:ext cx="3059708" cy="548248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0017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460043"/>
            <a:ext cx="6209407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118188"/>
            <a:ext cx="3045646" cy="103809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156278"/>
            <a:ext cx="3045646" cy="46424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118188"/>
            <a:ext cx="3060646" cy="103809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156278"/>
            <a:ext cx="3060646" cy="46424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2332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663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12192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76051"/>
            <a:ext cx="2321966" cy="2016178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244112"/>
            <a:ext cx="3644652" cy="614054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592229"/>
            <a:ext cx="2321966" cy="480242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845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576051"/>
            <a:ext cx="2321966" cy="2016178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244112"/>
            <a:ext cx="3644652" cy="614054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592229"/>
            <a:ext cx="2321966" cy="4802425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9803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460043"/>
            <a:ext cx="6209407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300203"/>
            <a:ext cx="6209407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8008709"/>
            <a:ext cx="161984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8008709"/>
            <a:ext cx="2429768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8008709"/>
            <a:ext cx="161984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8936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C064A351-60ED-4596-9799-BF6841B943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2672" y="141387"/>
            <a:ext cx="3199109" cy="319910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CDA8CED-CF61-4E86-953C-70F2239A9FEE}"/>
              </a:ext>
            </a:extLst>
          </p:cNvPr>
          <p:cNvSpPr txBox="1"/>
          <p:nvPr/>
        </p:nvSpPr>
        <p:spPr>
          <a:xfrm>
            <a:off x="83648" y="106230"/>
            <a:ext cx="263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pic>
        <p:nvPicPr>
          <p:cNvPr id="12" name="Picture 2">
            <a:extLst>
              <a:ext uri="{FF2B5EF4-FFF2-40B4-BE49-F238E27FC236}">
                <a16:creationId xmlns:a16="http://schemas.microsoft.com/office/drawing/2014/main" id="{C809DB06-0CC1-4073-B1DE-33048841436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724364" y="141695"/>
            <a:ext cx="3199109" cy="3199109"/>
          </a:xfrm>
          <a:prstGeom prst="rect">
            <a:avLst/>
          </a:prstGeom>
        </p:spPr>
      </p:pic>
      <p:pic>
        <p:nvPicPr>
          <p:cNvPr id="13" name="Picture 2">
            <a:extLst>
              <a:ext uri="{FF2B5EF4-FFF2-40B4-BE49-F238E27FC236}">
                <a16:creationId xmlns:a16="http://schemas.microsoft.com/office/drawing/2014/main" id="{AF151C65-BE80-41E7-97EB-FA4B61C4098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03135" y="3784588"/>
            <a:ext cx="3199109" cy="3199109"/>
          </a:xfrm>
          <a:prstGeom prst="rect">
            <a:avLst/>
          </a:prstGeom>
        </p:spPr>
      </p:pic>
      <p:sp>
        <p:nvSpPr>
          <p:cNvPr id="14" name="TextBox 6">
            <a:extLst>
              <a:ext uri="{FF2B5EF4-FFF2-40B4-BE49-F238E27FC236}">
                <a16:creationId xmlns:a16="http://schemas.microsoft.com/office/drawing/2014/main" id="{CF31A791-AC95-4561-8CB0-DFDD56886BD3}"/>
              </a:ext>
            </a:extLst>
          </p:cNvPr>
          <p:cNvSpPr txBox="1"/>
          <p:nvPr/>
        </p:nvSpPr>
        <p:spPr>
          <a:xfrm>
            <a:off x="83648" y="3659903"/>
            <a:ext cx="2632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pic>
        <p:nvPicPr>
          <p:cNvPr id="15" name="Picture 2">
            <a:extLst>
              <a:ext uri="{FF2B5EF4-FFF2-40B4-BE49-F238E27FC236}">
                <a16:creationId xmlns:a16="http://schemas.microsoft.com/office/drawing/2014/main" id="{3D2171F9-7CB9-467E-B927-6FE661CEFDB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740549" y="3784896"/>
            <a:ext cx="3199109" cy="3199109"/>
          </a:xfrm>
          <a:prstGeom prst="rect">
            <a:avLst/>
          </a:prstGeom>
        </p:spPr>
      </p:pic>
      <p:sp>
        <p:nvSpPr>
          <p:cNvPr id="22" name="文本框 9">
            <a:extLst>
              <a:ext uri="{FF2B5EF4-FFF2-40B4-BE49-F238E27FC236}">
                <a16:creationId xmlns:a16="http://schemas.microsoft.com/office/drawing/2014/main" id="{4880ED61-F3C1-4A76-AC56-4676133E7864}"/>
              </a:ext>
            </a:extLst>
          </p:cNvPr>
          <p:cNvSpPr txBox="1"/>
          <p:nvPr/>
        </p:nvSpPr>
        <p:spPr>
          <a:xfrm>
            <a:off x="131146" y="7118935"/>
            <a:ext cx="685601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7. </a:t>
            </a:r>
            <a:r>
              <a:rPr lang="en-HK" altLang="zh-CN" sz="14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fferentially abundant</a:t>
            </a:r>
            <a:r>
              <a:rPr lang="en-HK" altLang="zh-CN" sz="14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cterial species show direct trends along CRC progression. 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eptotrichia</a:t>
            </a:r>
            <a:r>
              <a:rPr lang="en-US" altLang="zh-CN" sz="1400" i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uccalis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and</a:t>
            </a:r>
            <a:r>
              <a:rPr lang="en-US" altLang="zh-CN" sz="1400" i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revotella</a:t>
            </a:r>
            <a:r>
              <a:rPr lang="en-US" altLang="zh-CN" sz="1400" i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eroralis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ignificantly increased along CRC progression. </a:t>
            </a:r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chnospiraceae</a:t>
            </a:r>
            <a:r>
              <a:rPr lang="en-US" altLang="zh-CN" sz="1400" i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bacterium 14-56FAA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nd</a:t>
            </a:r>
            <a:r>
              <a:rPr lang="en-US" altLang="zh-CN" sz="1400" i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Eubacterium </a:t>
            </a:r>
            <a:r>
              <a:rPr lang="en-US" altLang="zh-CN" sz="1400" i="1" dirty="0" err="1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olichum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significantly decreased along CRC progression. </a:t>
            </a:r>
            <a:r>
              <a:rPr lang="en-HK" altLang="zh-CN" sz="1400" kern="0" dirty="0">
                <a:solidFill>
                  <a:srgbClr val="202124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irwise comparisons were performed using Wilcoxon rank-sum test. CRC; colorectal cancer, CRA; colorectal adenoma, NC; normal control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0</TotalTime>
  <Words>70</Words>
  <Application>Microsoft Office PowerPoint</Application>
  <PresentationFormat>Custom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69</cp:revision>
  <dcterms:created xsi:type="dcterms:W3CDTF">2020-10-05T01:00:00Z</dcterms:created>
  <dcterms:modified xsi:type="dcterms:W3CDTF">2021-10-21T15:19:42Z</dcterms:modified>
</cp:coreProperties>
</file>